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6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rosoft Office User" initials="MOU" lastIdx="2" clrIdx="0"/>
  <p:cmAuthor id="2" name="Microsoft Office User" initials="Office" lastIdx="6" clrIdx="1"/>
  <p:cmAuthor id="3" name="Laetitia Comps-Agrar" initials="LCA" lastIdx="1" clrIdx="2">
    <p:extLst>
      <p:ext uri="{19B8F6BF-5375-455C-9EA6-DF929625EA0E}">
        <p15:presenceInfo xmlns:p15="http://schemas.microsoft.com/office/powerpoint/2012/main" userId="Laetitia Comps-Agra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539" autoAdjust="0"/>
    <p:restoredTop sz="94141" autoAdjust="0"/>
  </p:normalViewPr>
  <p:slideViewPr>
    <p:cSldViewPr snapToGrid="0" snapToObjects="1">
      <p:cViewPr varScale="1">
        <p:scale>
          <a:sx n="53" d="100"/>
          <a:sy n="53" d="100"/>
        </p:scale>
        <p:origin x="2394" y="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62DEF5-F50D-40CB-B0C7-37A9663CE3B6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F4862D-3836-4C43-BD89-E5BE2B1EDE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7132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DF4862D-3836-4C43-BD89-E5BE2B1EDEE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6169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177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77945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9774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609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3686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3510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2860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1510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3895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1275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724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3981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CD3AA3E5-7137-5945-A4C3-91FA14D2427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3700" y="1016448"/>
            <a:ext cx="2614688" cy="2157770"/>
          </a:xfrm>
          <a:prstGeom prst="rect">
            <a:avLst/>
          </a:prstGeom>
        </p:spPr>
      </p:pic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xmlns="" id="{D476CF52-0ACA-4646-A168-DA7C3C0684E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55900546"/>
              </p:ext>
            </p:extLst>
          </p:nvPr>
        </p:nvGraphicFramePr>
        <p:xfrm>
          <a:off x="1043768" y="3592681"/>
          <a:ext cx="4477656" cy="940818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970452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38472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127018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995466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405872"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67287" marR="167287" marT="83644" marB="83644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a</a:t>
                      </a:r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1/</a:t>
                      </a:r>
                      <a:r>
                        <a:rPr lang="en-US" sz="1200" b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</a:t>
                      </a:r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67287" marR="167287" marT="83644" marB="83644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</a:t>
                      </a:r>
                      <a:r>
                        <a:rPr lang="cs-CZ" sz="12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1/s)</a:t>
                      </a:r>
                      <a:endParaRPr lang="cs-CZ" sz="12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234" marR="23234" marT="23234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 (</a:t>
                      </a:r>
                      <a:r>
                        <a:rPr lang="en-US" sz="1200" b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234" marR="23234" marT="23234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6747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21C7</a:t>
                      </a:r>
                      <a:endParaRPr lang="en-US" sz="12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3234" marR="23234" marT="2323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1E+05</a:t>
                      </a:r>
                    </a:p>
                  </a:txBody>
                  <a:tcPr marL="17426" marR="17426" marT="17426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6E-04</a:t>
                      </a:r>
                    </a:p>
                  </a:txBody>
                  <a:tcPr marL="17426" marR="17426" marT="17426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1</a:t>
                      </a:r>
                    </a:p>
                  </a:txBody>
                  <a:tcPr marL="17426" marR="17426" marT="17426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2196853385"/>
                  </a:ext>
                </a:extLst>
              </a:tr>
              <a:tr h="26747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F10</a:t>
                      </a:r>
                    </a:p>
                  </a:txBody>
                  <a:tcPr marL="23234" marR="23234" marT="2323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2E+05</a:t>
                      </a:r>
                    </a:p>
                  </a:txBody>
                  <a:tcPr marL="17426" marR="17426" marT="17426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3E-04</a:t>
                      </a:r>
                    </a:p>
                  </a:txBody>
                  <a:tcPr marL="17426" marR="17426" marT="17426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7</a:t>
                      </a:r>
                    </a:p>
                  </a:txBody>
                  <a:tcPr marL="17426" marR="17426" marT="17426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</a:tbl>
          </a:graphicData>
        </a:graphic>
      </p:graphicFrame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164FC10E-90E1-7F4A-BB37-D8DAE1E29F52}"/>
              </a:ext>
            </a:extLst>
          </p:cNvPr>
          <p:cNvPicPr>
            <a:picLocks noChangeAspect="1"/>
          </p:cNvPicPr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3107750" y="899174"/>
            <a:ext cx="2756795" cy="2275044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56C4BD11-C443-4541-9107-E38A6CA5B270}"/>
              </a:ext>
            </a:extLst>
          </p:cNvPr>
          <p:cNvSpPr txBox="1"/>
          <p:nvPr/>
        </p:nvSpPr>
        <p:spPr>
          <a:xfrm>
            <a:off x="820648" y="1083548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038D6BF6-89FB-034D-AA95-3FDECEDDBFE5}"/>
              </a:ext>
            </a:extLst>
          </p:cNvPr>
          <p:cNvSpPr txBox="1"/>
          <p:nvPr/>
        </p:nvSpPr>
        <p:spPr>
          <a:xfrm>
            <a:off x="3107750" y="1083548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3F39FD49-1821-BF48-807D-0D8A278DD0A0}"/>
              </a:ext>
            </a:extLst>
          </p:cNvPr>
          <p:cNvSpPr txBox="1"/>
          <p:nvPr/>
        </p:nvSpPr>
        <p:spPr>
          <a:xfrm>
            <a:off x="766139" y="3174218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7CF7833B-FC37-2D46-AC34-A7B8CBCD1B60}"/>
              </a:ext>
            </a:extLst>
          </p:cNvPr>
          <p:cNvSpPr txBox="1"/>
          <p:nvPr/>
        </p:nvSpPr>
        <p:spPr>
          <a:xfrm>
            <a:off x="4221510" y="2991034"/>
            <a:ext cx="849913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ime (sec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51471AB6-D3C3-B445-8A9F-F2F2194D95A7}"/>
              </a:ext>
            </a:extLst>
          </p:cNvPr>
          <p:cNvSpPr txBox="1"/>
          <p:nvPr/>
        </p:nvSpPr>
        <p:spPr>
          <a:xfrm>
            <a:off x="1838836" y="3013885"/>
            <a:ext cx="849913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ime (sec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EEFA45A2-5592-ED4D-8ECC-291E65021E7C}"/>
              </a:ext>
            </a:extLst>
          </p:cNvPr>
          <p:cNvSpPr txBox="1"/>
          <p:nvPr/>
        </p:nvSpPr>
        <p:spPr>
          <a:xfrm rot="16200000">
            <a:off x="266002" y="2031515"/>
            <a:ext cx="1518364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esponse Units (RU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EBC72D15-B7B8-FB42-85DA-587014483096}"/>
              </a:ext>
            </a:extLst>
          </p:cNvPr>
          <p:cNvSpPr txBox="1"/>
          <p:nvPr/>
        </p:nvSpPr>
        <p:spPr>
          <a:xfrm rot="16200000">
            <a:off x="2585962" y="2031515"/>
            <a:ext cx="1518364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esponse Units (RU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B1B19475-AA37-594D-9682-39B4405A9707}"/>
              </a:ext>
            </a:extLst>
          </p:cNvPr>
          <p:cNvSpPr txBox="1"/>
          <p:nvPr/>
        </p:nvSpPr>
        <p:spPr>
          <a:xfrm>
            <a:off x="134112" y="269187"/>
            <a:ext cx="67238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dditional file 3: Figure S3</a:t>
            </a:r>
          </a:p>
        </p:txBody>
      </p:sp>
    </p:spTree>
    <p:extLst>
      <p:ext uri="{BB962C8B-B14F-4D97-AF65-F5344CB8AC3E}">
        <p14:creationId xmlns:p14="http://schemas.microsoft.com/office/powerpoint/2010/main" val="41785694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4249</TotalTime>
  <Words>51</Words>
  <Application>Microsoft Office PowerPoint</Application>
  <PresentationFormat>On-screen Show (4:3)</PresentationFormat>
  <Paragraphs>2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Rajeshwari A.</cp:lastModifiedBy>
  <cp:revision>524</cp:revision>
  <cp:lastPrinted>2019-10-09T17:57:08Z</cp:lastPrinted>
  <dcterms:created xsi:type="dcterms:W3CDTF">2019-08-20T22:35:14Z</dcterms:created>
  <dcterms:modified xsi:type="dcterms:W3CDTF">2021-12-10T14:10:57Z</dcterms:modified>
</cp:coreProperties>
</file>